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1" r:id="rId4"/>
    <p:sldId id="262" r:id="rId5"/>
    <p:sldId id="263" r:id="rId6"/>
    <p:sldId id="258" r:id="rId7"/>
    <p:sldId id="266" r:id="rId8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DD38961-913F-5327-CDDB-82A5260662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EE34F062-578A-956A-4BC6-9FD23B0307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449350E-8DBA-310E-3D0B-FB90B6666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7FA54D1-704D-1B08-C29B-EFD5A3F49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0A54274-D297-BA08-F843-AA543EC48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57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27F17FE-0834-E7AF-B923-4D5309E0D3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A9F08D6-386A-3FE7-FFDE-7BE26FFE17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DD9081A-B533-6845-FD56-DCB42C6445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D08CA77-AE85-829E-8510-9C928E21F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7838B2-5C07-9EF9-1E8F-C8C350047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7607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944955C-E5E5-C956-8C94-D34103250F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659E007-F88F-BF38-049A-09F4EC7E6C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6323D2A-EA5B-9452-D896-F1FE3399D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A94B86-04B9-AB07-2E4D-BD4A06B84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88959A1-52D9-0DEC-B38E-089C3570F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6640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5797ADC-01F0-E482-E184-FDEE22532B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B78CCB1-59FA-F615-C9A5-A65CE04319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39C7F15-BCF5-C7DF-FB3B-272DF7132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FE14626-E426-1644-9A5A-BDAF1920A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0CEEEF2-99A8-6339-C16D-03C29D4B2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2124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D7F2A07-7CAC-6D09-6BA8-1AA57BD6A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8FCD7A3-B120-C846-AC9E-32AC70314F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D75A7E4-2A9A-6ADA-6BF1-156F4A8872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E30D156-AAEC-E0D1-D401-40A015A21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4483816-E29D-8696-9AFF-1B022EFB7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719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661694F-980C-3694-4696-81A5EB750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97A3CD6-3BB6-C89C-7A5C-A8D7A16B89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90E95A4-CB20-DA6F-FADE-F8DB1368A5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444B8CF-D530-2689-7282-5BAE9DE95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659D161-60C2-3AFC-9336-7B25F216D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96A7832-48D7-F427-2931-A60B9C5D5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605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476D28-AADD-B800-0FAC-53B43DA5F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57B4F84-C5A0-AE0F-2FDC-ABE214255B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E40C444-A76E-19BD-949A-6D3B75D4B6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D31562E-6150-25D9-D33A-CBB453C8FD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5D9A212-AFDA-EA0F-4514-4F8CA9E125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96BC630-2C61-24B6-396D-78C69A037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0136442-4105-C4AB-E0C1-38C9A904F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0BC9E24-97E1-46F4-50C5-3F8DEDB1D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6753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EA4A4B1-7991-37FF-EC0C-136E143B6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33BDEAE-65FF-91AE-300F-7B16ED0F2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8C4F2F0-9B69-351E-2F1A-30CC75E17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FB53599C-DF56-6CDC-09AA-37E56E8FD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4090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177164A-C935-B2D7-30B6-0A2A5F9FE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6A67ADD-7ED0-C920-9153-A609C75D0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BD476F4-2325-EACE-6345-30F5CB70C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4381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737226-7D6B-8B00-4DCB-3BD658A1D1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AC026FF-0FF2-A074-4BB8-04E17ECCE1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CFF5D83-3B90-62B3-9D7D-398B47425A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0DB0D1D-199D-3226-E48B-144626002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7F297E9-A54F-3AA2-F16F-AC777F8CE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6E58B8C-5287-17C0-5694-1191B4E87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363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C75A7-DF6F-6B3E-BD05-D6EDB09BDF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F31EC2CA-261D-5B5B-E9EB-1F3A7ABDFE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476317B-1CC8-F1D3-F992-B9458E6945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B551F3F-455D-8972-F7CD-682EC3A28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F0519CE-68A7-178B-6612-77C6EB30E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7008E07-2619-7CDC-E94B-B9EEF56C4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3130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357BD2A-93B9-A203-9E6A-F73E88FEE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DE20819-2BAC-0AA0-BE5F-80BAB1508E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068AD2E-00CD-CC40-B4A5-522752E9A5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694C0-2177-4123-9310-5DD02FEE4712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4BB77F0-6A8A-BFF0-0813-2BC678FCD5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FC22173-78A3-79F6-9C9E-E4E7347D54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CADB9-14D2-4230-A7F0-B8DCB08BD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0735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513F12E9-7F64-AE0A-F2EC-D228E3B214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8693" y="563296"/>
            <a:ext cx="9934614" cy="619268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158BDCF-7784-1D96-E14D-A1EF76F2EA19}"/>
              </a:ext>
            </a:extLst>
          </p:cNvPr>
          <p:cNvSpPr txBox="1"/>
          <p:nvPr/>
        </p:nvSpPr>
        <p:spPr>
          <a:xfrm>
            <a:off x="138545" y="193964"/>
            <a:ext cx="6105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1</a:t>
            </a:r>
            <a:endParaRPr lang="ko-KR" altLang="en-US" dirty="0"/>
          </a:p>
        </p:txBody>
      </p:sp>
      <p:sp>
        <p:nvSpPr>
          <p:cNvPr id="4" name="화살표: 아래쪽 3">
            <a:extLst>
              <a:ext uri="{FF2B5EF4-FFF2-40B4-BE49-F238E27FC236}">
                <a16:creationId xmlns:a16="http://schemas.microsoft.com/office/drawing/2014/main" id="{215EF50A-C16C-0F68-3625-53F3E08A85E2}"/>
              </a:ext>
            </a:extLst>
          </p:cNvPr>
          <p:cNvSpPr/>
          <p:nvPr/>
        </p:nvSpPr>
        <p:spPr>
          <a:xfrm>
            <a:off x="4021718" y="258558"/>
            <a:ext cx="208537" cy="46181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62500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74BBD540-7D74-50F1-1313-9E55A34AD5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019" y="769734"/>
            <a:ext cx="9206380" cy="58206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C6E35FE-C733-7916-4AB9-93A9DA3CC0E3}"/>
              </a:ext>
            </a:extLst>
          </p:cNvPr>
          <p:cNvSpPr txBox="1"/>
          <p:nvPr/>
        </p:nvSpPr>
        <p:spPr>
          <a:xfrm>
            <a:off x="138545" y="193964"/>
            <a:ext cx="6105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2</a:t>
            </a:r>
            <a:endParaRPr lang="ko-KR" altLang="en-US" dirty="0"/>
          </a:p>
        </p:txBody>
      </p:sp>
      <p:sp>
        <p:nvSpPr>
          <p:cNvPr id="5" name="화살표: 아래쪽 4">
            <a:extLst>
              <a:ext uri="{FF2B5EF4-FFF2-40B4-BE49-F238E27FC236}">
                <a16:creationId xmlns:a16="http://schemas.microsoft.com/office/drawing/2014/main" id="{7A98B1EB-98A4-9C5F-A9C2-BA6B885C9375}"/>
              </a:ext>
            </a:extLst>
          </p:cNvPr>
          <p:cNvSpPr/>
          <p:nvPr/>
        </p:nvSpPr>
        <p:spPr>
          <a:xfrm>
            <a:off x="8833863" y="2133598"/>
            <a:ext cx="208537" cy="46181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90526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8B1B51-042D-4426-B7D8-4B0DAB7FAB9A}"/>
              </a:ext>
            </a:extLst>
          </p:cNvPr>
          <p:cNvSpPr txBox="1"/>
          <p:nvPr/>
        </p:nvSpPr>
        <p:spPr>
          <a:xfrm>
            <a:off x="138545" y="193964"/>
            <a:ext cx="6105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3</a:t>
            </a:r>
            <a:endParaRPr lang="ko-KR" altLang="en-US" dirty="0"/>
          </a:p>
        </p:txBody>
      </p:sp>
      <p:pic>
        <p:nvPicPr>
          <p:cNvPr id="3" name="그림 2" descr="차트이(가) 표시된 사진&#10;&#10;자동 생성된 설명">
            <a:extLst>
              <a:ext uri="{FF2B5EF4-FFF2-40B4-BE49-F238E27FC236}">
                <a16:creationId xmlns:a16="http://schemas.microsoft.com/office/drawing/2014/main" id="{508B8492-8E61-B486-9EE7-2F7625FC67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563" y="809405"/>
            <a:ext cx="11249891" cy="5854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46140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4A57EE-C4F0-AADA-BAF5-59A83C941C64}"/>
              </a:ext>
            </a:extLst>
          </p:cNvPr>
          <p:cNvSpPr txBox="1"/>
          <p:nvPr/>
        </p:nvSpPr>
        <p:spPr>
          <a:xfrm>
            <a:off x="138545" y="193964"/>
            <a:ext cx="6105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4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764C3EF3-ACAD-2275-78D5-69B0071D2B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982" y="993348"/>
            <a:ext cx="10980738" cy="4603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62098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8A55A5E-D959-0A2E-A973-D3664EFF0DE8}"/>
              </a:ext>
            </a:extLst>
          </p:cNvPr>
          <p:cNvSpPr txBox="1"/>
          <p:nvPr/>
        </p:nvSpPr>
        <p:spPr>
          <a:xfrm>
            <a:off x="138545" y="193964"/>
            <a:ext cx="6105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5</a:t>
            </a:r>
            <a:endParaRPr lang="ko-KR" altLang="en-US" dirty="0"/>
          </a:p>
        </p:txBody>
      </p:sp>
      <p:pic>
        <p:nvPicPr>
          <p:cNvPr id="3" name="그림 2" descr="차트이(가) 표시된 사진">
            <a:extLst>
              <a:ext uri="{FF2B5EF4-FFF2-40B4-BE49-F238E27FC236}">
                <a16:creationId xmlns:a16="http://schemas.microsoft.com/office/drawing/2014/main" id="{7C347DDA-6DD8-E6D2-C256-AE81A11C9A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27" y="831618"/>
            <a:ext cx="10825017" cy="5493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38069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 descr="차트이(가) 표시된 사진&#10;&#10;자동 생성된 설명">
            <a:extLst>
              <a:ext uri="{FF2B5EF4-FFF2-40B4-BE49-F238E27FC236}">
                <a16:creationId xmlns:a16="http://schemas.microsoft.com/office/drawing/2014/main" id="{1346531C-6E7D-9E26-3E7E-E6A1AA5EF4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3296"/>
            <a:ext cx="12192000" cy="6223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5931E85-59B7-15C8-8487-CFD3FBA49B08}"/>
              </a:ext>
            </a:extLst>
          </p:cNvPr>
          <p:cNvSpPr txBox="1"/>
          <p:nvPr/>
        </p:nvSpPr>
        <p:spPr>
          <a:xfrm>
            <a:off x="138545" y="193964"/>
            <a:ext cx="6105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6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908281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D305638-2E68-786D-0AB7-9F917195BA27}"/>
              </a:ext>
            </a:extLst>
          </p:cNvPr>
          <p:cNvSpPr txBox="1"/>
          <p:nvPr/>
        </p:nvSpPr>
        <p:spPr>
          <a:xfrm>
            <a:off x="138545" y="193964"/>
            <a:ext cx="6105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7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093663C1-F893-99EA-107C-57784EFDBF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781583"/>
            <a:ext cx="11526982" cy="5542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4722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21</Words>
  <Application>Microsoft Office PowerPoint</Application>
  <PresentationFormat>와이드스크린</PresentationFormat>
  <Paragraphs>7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0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온정헌</dc:creator>
  <cp:lastModifiedBy>온정헌</cp:lastModifiedBy>
  <cp:revision>32</cp:revision>
  <dcterms:created xsi:type="dcterms:W3CDTF">2023-02-16T07:31:28Z</dcterms:created>
  <dcterms:modified xsi:type="dcterms:W3CDTF">2023-12-15T09:55:36Z</dcterms:modified>
</cp:coreProperties>
</file>